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8" r:id="rId5"/>
    <p:sldId id="281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iin Von Weitershausen, Zoe" initials="FVWZ" lastIdx="4" clrIdx="0">
    <p:extLst>
      <p:ext uri="{19B8F6BF-5375-455C-9EA6-DF929625EA0E}">
        <p15:presenceInfo xmlns:p15="http://schemas.microsoft.com/office/powerpoint/2012/main" userId="Freiin Von Weitershausen, Zo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0000"/>
    <a:srgbClr val="FF0002"/>
    <a:srgbClr val="FBFB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41" autoAdjust="0"/>
    <p:restoredTop sz="94660"/>
  </p:normalViewPr>
  <p:slideViewPr>
    <p:cSldViewPr snapToGrid="0">
      <p:cViewPr varScale="1">
        <p:scale>
          <a:sx n="68" d="100"/>
          <a:sy n="68" d="100"/>
        </p:scale>
        <p:origin x="76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12" Type="http://schemas.openxmlformats.org/officeDocument/2006/relationships/image" Target="../media/image29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emf"/><Relationship Id="rId11" Type="http://schemas.openxmlformats.org/officeDocument/2006/relationships/image" Target="../media/image28.emf"/><Relationship Id="rId5" Type="http://schemas.openxmlformats.org/officeDocument/2006/relationships/image" Target="../media/image22.emf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1007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900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159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410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3497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009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2141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6071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1305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4083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6995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0EBEB-47E4-42E8-8E59-3D7D6AA8CD91}" type="datetimeFigureOut">
              <a:rPr lang="de-DE" smtClean="0"/>
              <a:t>04.06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1B00F0-AC76-405A-8E07-BFD86E6B09F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9074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9.emf"/><Relationship Id="rId34" Type="http://schemas.openxmlformats.org/officeDocument/2006/relationships/oleObject" Target="../embeddings/oleObject16.bin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openxmlformats.org/officeDocument/2006/relationships/image" Target="../media/image11.emf"/><Relationship Id="rId33" Type="http://schemas.openxmlformats.org/officeDocument/2006/relationships/image" Target="../media/image15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29" Type="http://schemas.openxmlformats.org/officeDocument/2006/relationships/image" Target="../media/image13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oleObject" Target="../embeddings/oleObject11.bin"/><Relationship Id="rId32" Type="http://schemas.openxmlformats.org/officeDocument/2006/relationships/oleObject" Target="../embeddings/oleObject15.bin"/><Relationship Id="rId5" Type="http://schemas.openxmlformats.org/officeDocument/2006/relationships/image" Target="../media/image17.emf"/><Relationship Id="rId15" Type="http://schemas.openxmlformats.org/officeDocument/2006/relationships/image" Target="../media/image6.emf"/><Relationship Id="rId23" Type="http://schemas.openxmlformats.org/officeDocument/2006/relationships/image" Target="../media/image10.emf"/><Relationship Id="rId28" Type="http://schemas.openxmlformats.org/officeDocument/2006/relationships/oleObject" Target="../embeddings/oleObject13.bin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31" Type="http://schemas.openxmlformats.org/officeDocument/2006/relationships/image" Target="../media/image14.emf"/><Relationship Id="rId4" Type="http://schemas.openxmlformats.org/officeDocument/2006/relationships/image" Target="../media/image1.emf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2.e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16.emf"/><Relationship Id="rId8" Type="http://schemas.openxmlformats.org/officeDocument/2006/relationships/oleObject" Target="../embeddings/oleObject3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9.bin"/><Relationship Id="rId13" Type="http://schemas.openxmlformats.org/officeDocument/2006/relationships/image" Target="../media/image22.emf"/><Relationship Id="rId18" Type="http://schemas.openxmlformats.org/officeDocument/2006/relationships/oleObject" Target="../embeddings/oleObject24.bin"/><Relationship Id="rId26" Type="http://schemas.openxmlformats.org/officeDocument/2006/relationships/oleObject" Target="../embeddings/oleObject28.bin"/><Relationship Id="rId3" Type="http://schemas.openxmlformats.org/officeDocument/2006/relationships/image" Target="../media/image17.emf"/><Relationship Id="rId21" Type="http://schemas.openxmlformats.org/officeDocument/2006/relationships/image" Target="../media/image26.emf"/><Relationship Id="rId7" Type="http://schemas.openxmlformats.org/officeDocument/2006/relationships/image" Target="../media/image19.emf"/><Relationship Id="rId12" Type="http://schemas.openxmlformats.org/officeDocument/2006/relationships/oleObject" Target="../embeddings/oleObject21.bin"/><Relationship Id="rId17" Type="http://schemas.openxmlformats.org/officeDocument/2006/relationships/image" Target="../media/image24.emf"/><Relationship Id="rId25" Type="http://schemas.openxmlformats.org/officeDocument/2006/relationships/image" Target="../media/image28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23.bin"/><Relationship Id="rId20" Type="http://schemas.openxmlformats.org/officeDocument/2006/relationships/oleObject" Target="../embeddings/oleObject25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18.bin"/><Relationship Id="rId11" Type="http://schemas.openxmlformats.org/officeDocument/2006/relationships/image" Target="../media/image21.emf"/><Relationship Id="rId24" Type="http://schemas.openxmlformats.org/officeDocument/2006/relationships/oleObject" Target="../embeddings/oleObject27.bin"/><Relationship Id="rId5" Type="http://schemas.openxmlformats.org/officeDocument/2006/relationships/image" Target="../media/image18.emf"/><Relationship Id="rId15" Type="http://schemas.openxmlformats.org/officeDocument/2006/relationships/image" Target="../media/image23.emf"/><Relationship Id="rId23" Type="http://schemas.openxmlformats.org/officeDocument/2006/relationships/image" Target="../media/image27.emf"/><Relationship Id="rId10" Type="http://schemas.openxmlformats.org/officeDocument/2006/relationships/oleObject" Target="../embeddings/oleObject20.bin"/><Relationship Id="rId19" Type="http://schemas.openxmlformats.org/officeDocument/2006/relationships/image" Target="../media/image25.emf"/><Relationship Id="rId4" Type="http://schemas.openxmlformats.org/officeDocument/2006/relationships/oleObject" Target="../embeddings/oleObject17.bin"/><Relationship Id="rId9" Type="http://schemas.openxmlformats.org/officeDocument/2006/relationships/image" Target="../media/image20.emf"/><Relationship Id="rId14" Type="http://schemas.openxmlformats.org/officeDocument/2006/relationships/oleObject" Target="../embeddings/oleObject22.bin"/><Relationship Id="rId22" Type="http://schemas.openxmlformats.org/officeDocument/2006/relationships/oleObject" Target="../embeddings/oleObject26.bin"/><Relationship Id="rId27" Type="http://schemas.openxmlformats.org/officeDocument/2006/relationships/image" Target="../media/image2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Objek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762775"/>
              </p:ext>
            </p:extLst>
          </p:nvPr>
        </p:nvGraphicFramePr>
        <p:xfrm>
          <a:off x="4714875" y="5183188"/>
          <a:ext cx="1851025" cy="152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4" name="Prism 9" r:id="rId3" imgW="1850737" imgH="1526333" progId="Prism9.Document">
                  <p:embed/>
                </p:oleObj>
              </mc:Choice>
              <mc:Fallback>
                <p:oleObj name="Prism 9" r:id="rId3" imgW="1850737" imgH="152633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14875" y="5183188"/>
                        <a:ext cx="1851025" cy="152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feld 17">
            <a:extLst>
              <a:ext uri="{FF2B5EF4-FFF2-40B4-BE49-F238E27FC236}">
                <a16:creationId xmlns:a16="http://schemas.microsoft.com/office/drawing/2014/main" id="{A8BF01D9-35E3-DE41-9C79-DDAA4AC886A8}"/>
              </a:ext>
            </a:extLst>
          </p:cNvPr>
          <p:cNvSpPr txBox="1"/>
          <p:nvPr/>
        </p:nvSpPr>
        <p:spPr>
          <a:xfrm>
            <a:off x="92157" y="98037"/>
            <a:ext cx="761747" cy="369332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dirty="0" err="1">
                <a:solidFill>
                  <a:schemeClr val="bg1"/>
                </a:solidFill>
              </a:rPr>
              <a:t>Sup</a:t>
            </a:r>
            <a:r>
              <a:rPr lang="de-DE" dirty="0">
                <a:solidFill>
                  <a:schemeClr val="bg1"/>
                </a:solidFill>
              </a:rPr>
              <a:t>. 1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4005191" y="6511667"/>
            <a:ext cx="42672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1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639763" y="6517437"/>
            <a:ext cx="46358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I1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5248200" y="6517437"/>
            <a:ext cx="62549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luR5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Grafik 22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9361" t="23445" r="69186" b="74686"/>
          <a:stretch/>
        </p:blipFill>
        <p:spPr>
          <a:xfrm>
            <a:off x="3041033" y="6533364"/>
            <a:ext cx="186264" cy="226722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135" t="31412" r="62560" b="66731"/>
          <a:stretch/>
        </p:blipFill>
        <p:spPr>
          <a:xfrm>
            <a:off x="3851748" y="6525373"/>
            <a:ext cx="156528" cy="210706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884" t="33871" r="35896" b="64538"/>
          <a:stretch/>
        </p:blipFill>
        <p:spPr>
          <a:xfrm>
            <a:off x="4486378" y="6544744"/>
            <a:ext cx="156470" cy="192883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3016" t="34233" r="15866" b="64512"/>
          <a:stretch/>
        </p:blipFill>
        <p:spPr>
          <a:xfrm>
            <a:off x="5100973" y="6572922"/>
            <a:ext cx="150312" cy="159544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3224212" y="6519446"/>
            <a:ext cx="61266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402122" y="19852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2402122" y="1803599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2402122" y="3495181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2402122" y="5085163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2454103" y="2109171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de-DE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</a:p>
        </p:txBody>
      </p:sp>
      <p:graphicFrame>
        <p:nvGraphicFramePr>
          <p:cNvPr id="36" name="Objek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3251698"/>
              </p:ext>
            </p:extLst>
          </p:nvPr>
        </p:nvGraphicFramePr>
        <p:xfrm>
          <a:off x="2970343" y="1986328"/>
          <a:ext cx="1847850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5" name="Prism 9" r:id="rId6" imgW="1847856" imgH="1532455" progId="Prism9.Document">
                  <p:embed/>
                </p:oleObj>
              </mc:Choice>
              <mc:Fallback>
                <p:oleObj name="Prism 9" r:id="rId6" imgW="1847856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70343" y="1986328"/>
                        <a:ext cx="1847850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k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7333600"/>
              </p:ext>
            </p:extLst>
          </p:nvPr>
        </p:nvGraphicFramePr>
        <p:xfrm>
          <a:off x="4738500" y="1419035"/>
          <a:ext cx="1847850" cy="2109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6" name="Prism 9" r:id="rId8" imgW="1847856" imgH="2110143" progId="Prism9.Document">
                  <p:embed/>
                </p:oleObj>
              </mc:Choice>
              <mc:Fallback>
                <p:oleObj name="Prism 9" r:id="rId8" imgW="1847856" imgH="211014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738500" y="1419035"/>
                        <a:ext cx="1847850" cy="2109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k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8984824"/>
              </p:ext>
            </p:extLst>
          </p:nvPr>
        </p:nvGraphicFramePr>
        <p:xfrm>
          <a:off x="6446092" y="1468463"/>
          <a:ext cx="1884363" cy="2063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7" name="Prism 9" r:id="rId10" imgW="1884230" imgH="2062962" progId="Prism9.Document">
                  <p:embed/>
                </p:oleObj>
              </mc:Choice>
              <mc:Fallback>
                <p:oleObj name="Prism 9" r:id="rId10" imgW="1884230" imgH="2062962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446092" y="1468463"/>
                        <a:ext cx="1884363" cy="2063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k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9918613"/>
              </p:ext>
            </p:extLst>
          </p:nvPr>
        </p:nvGraphicFramePr>
        <p:xfrm>
          <a:off x="8271478" y="1431735"/>
          <a:ext cx="1847850" cy="2097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8" name="Prism 9" r:id="rId12" imgW="1847856" imgH="2096457" progId="Prism9.Document">
                  <p:embed/>
                </p:oleObj>
              </mc:Choice>
              <mc:Fallback>
                <p:oleObj name="Prism 9" r:id="rId12" imgW="1847856" imgH="2096457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271478" y="1431735"/>
                        <a:ext cx="1847850" cy="2097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feld 31"/>
          <p:cNvSpPr txBox="1"/>
          <p:nvPr/>
        </p:nvSpPr>
        <p:spPr>
          <a:xfrm>
            <a:off x="2454103" y="3793830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de-DE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</a:p>
        </p:txBody>
      </p:sp>
      <p:graphicFrame>
        <p:nvGraphicFramePr>
          <p:cNvPr id="40" name="Objek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2119127"/>
              </p:ext>
            </p:extLst>
          </p:nvPr>
        </p:nvGraphicFramePr>
        <p:xfrm>
          <a:off x="2920780" y="3226351"/>
          <a:ext cx="1893887" cy="2154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9" name="Prism 9" r:id="rId14" imgW="1893594" imgH="2154441" progId="Prism9.Document">
                  <p:embed/>
                </p:oleObj>
              </mc:Choice>
              <mc:Fallback>
                <p:oleObj name="Prism 9" r:id="rId14" imgW="1893594" imgH="2154441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20780" y="3226351"/>
                        <a:ext cx="1893887" cy="2154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k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030862"/>
              </p:ext>
            </p:extLst>
          </p:nvPr>
        </p:nvGraphicFramePr>
        <p:xfrm>
          <a:off x="4698462" y="3689900"/>
          <a:ext cx="1884363" cy="1681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0" name="Prism 9" r:id="rId16" imgW="1884230" imgH="1681559" progId="Prism9.Document">
                  <p:embed/>
                </p:oleObj>
              </mc:Choice>
              <mc:Fallback>
                <p:oleObj name="Prism 9" r:id="rId16" imgW="1884230" imgH="1681559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698462" y="3689900"/>
                        <a:ext cx="1884363" cy="1681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k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4472942"/>
              </p:ext>
            </p:extLst>
          </p:nvPr>
        </p:nvGraphicFramePr>
        <p:xfrm>
          <a:off x="6444154" y="3700734"/>
          <a:ext cx="1884363" cy="1666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1" name="Prism 9" r:id="rId18" imgW="1884230" imgH="1666433" progId="Prism9.Document">
                  <p:embed/>
                </p:oleObj>
              </mc:Choice>
              <mc:Fallback>
                <p:oleObj name="Prism 9" r:id="rId18" imgW="1884230" imgH="166643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444154" y="3700734"/>
                        <a:ext cx="1884363" cy="1666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k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4418584"/>
              </p:ext>
            </p:extLst>
          </p:nvPr>
        </p:nvGraphicFramePr>
        <p:xfrm>
          <a:off x="8231440" y="3354659"/>
          <a:ext cx="1884363" cy="201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2" name="Prism 9" r:id="rId20" imgW="1884230" imgH="2012541" progId="Prism9.Document">
                  <p:embed/>
                </p:oleObj>
              </mc:Choice>
              <mc:Fallback>
                <p:oleObj name="Prism 9" r:id="rId20" imgW="1884230" imgH="2012541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231440" y="3354659"/>
                        <a:ext cx="1884363" cy="201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feld 34"/>
          <p:cNvSpPr txBox="1"/>
          <p:nvPr/>
        </p:nvSpPr>
        <p:spPr>
          <a:xfrm>
            <a:off x="2454103" y="5393667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de-DE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RA</a:t>
            </a:r>
          </a:p>
        </p:txBody>
      </p:sp>
      <p:graphicFrame>
        <p:nvGraphicFramePr>
          <p:cNvPr id="48" name="Objek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5382892"/>
              </p:ext>
            </p:extLst>
          </p:nvPr>
        </p:nvGraphicFramePr>
        <p:xfrm>
          <a:off x="2930305" y="5180124"/>
          <a:ext cx="1884363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3" name="Prism 9" r:id="rId22" imgW="1884230" imgH="1532455" progId="Prism9.Document">
                  <p:embed/>
                </p:oleObj>
              </mc:Choice>
              <mc:Fallback>
                <p:oleObj name="Prism 9" r:id="rId22" imgW="1884230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930305" y="5180124"/>
                        <a:ext cx="1884363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Objekt 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8236483"/>
              </p:ext>
            </p:extLst>
          </p:nvPr>
        </p:nvGraphicFramePr>
        <p:xfrm>
          <a:off x="6444154" y="5187432"/>
          <a:ext cx="1884363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4" name="Prism 9" r:id="rId24" imgW="1884230" imgH="1532455" progId="Prism9.Document">
                  <p:embed/>
                </p:oleObj>
              </mc:Choice>
              <mc:Fallback>
                <p:oleObj name="Prism 9" r:id="rId24" imgW="1884230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6444154" y="5187432"/>
                        <a:ext cx="1884363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Objekt 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0489041"/>
              </p:ext>
            </p:extLst>
          </p:nvPr>
        </p:nvGraphicFramePr>
        <p:xfrm>
          <a:off x="8231440" y="5195773"/>
          <a:ext cx="1884363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5" name="Prism 9" r:id="rId26" imgW="1884230" imgH="1532455" progId="Prism9.Document">
                  <p:embed/>
                </p:oleObj>
              </mc:Choice>
              <mc:Fallback>
                <p:oleObj name="Prism 9" r:id="rId26" imgW="1884230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8231440" y="5195773"/>
                        <a:ext cx="1884363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feld 32"/>
          <p:cNvSpPr txBox="1"/>
          <p:nvPr/>
        </p:nvSpPr>
        <p:spPr>
          <a:xfrm>
            <a:off x="2454103" y="317076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de-DE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ive</a:t>
            </a:r>
          </a:p>
        </p:txBody>
      </p:sp>
      <p:graphicFrame>
        <p:nvGraphicFramePr>
          <p:cNvPr id="45" name="Objek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8705019"/>
              </p:ext>
            </p:extLst>
          </p:nvPr>
        </p:nvGraphicFramePr>
        <p:xfrm>
          <a:off x="4698462" y="132190"/>
          <a:ext cx="1884363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6" name="Prism 9" r:id="rId28" imgW="1884230" imgH="1532455" progId="Prism9.Document">
                  <p:embed/>
                </p:oleObj>
              </mc:Choice>
              <mc:Fallback>
                <p:oleObj name="Prism 9" r:id="rId28" imgW="1884230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4698462" y="132190"/>
                        <a:ext cx="1884363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k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9784463"/>
              </p:ext>
            </p:extLst>
          </p:nvPr>
        </p:nvGraphicFramePr>
        <p:xfrm>
          <a:off x="6444154" y="133574"/>
          <a:ext cx="1884363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7" name="Prism 9" r:id="rId30" imgW="1884230" imgH="1532455" progId="Prism9.Document">
                  <p:embed/>
                </p:oleObj>
              </mc:Choice>
              <mc:Fallback>
                <p:oleObj name="Prism 9" r:id="rId30" imgW="1884230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6444154" y="133574"/>
                        <a:ext cx="1884363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k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8192172"/>
              </p:ext>
            </p:extLst>
          </p:nvPr>
        </p:nvGraphicFramePr>
        <p:xfrm>
          <a:off x="8231440" y="130817"/>
          <a:ext cx="1884363" cy="153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8" name="Prism 9" r:id="rId32" imgW="1884230" imgH="1532455" progId="Prism9.Document">
                  <p:embed/>
                </p:oleObj>
              </mc:Choice>
              <mc:Fallback>
                <p:oleObj name="Prism 9" r:id="rId32" imgW="1884230" imgH="153245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8231440" y="130817"/>
                        <a:ext cx="1884363" cy="153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kt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7916228"/>
              </p:ext>
            </p:extLst>
          </p:nvPr>
        </p:nvGraphicFramePr>
        <p:xfrm>
          <a:off x="2930305" y="48497"/>
          <a:ext cx="1884363" cy="1619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9" name="Prism 9" r:id="rId34" imgW="1884230" imgH="1619253" progId="Prism9.Document">
                  <p:embed/>
                </p:oleObj>
              </mc:Choice>
              <mc:Fallback>
                <p:oleObj name="Prism 9" r:id="rId34" imgW="1884230" imgH="16192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2930305" y="48497"/>
                        <a:ext cx="1884363" cy="1619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6725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>
            <a:extLst>
              <a:ext uri="{FF2B5EF4-FFF2-40B4-BE49-F238E27FC236}">
                <a16:creationId xmlns:a16="http://schemas.microsoft.com/office/drawing/2014/main" id="{A8BF01D9-35E3-DE41-9C79-DDAA4AC886A8}"/>
              </a:ext>
            </a:extLst>
          </p:cNvPr>
          <p:cNvSpPr txBox="1"/>
          <p:nvPr/>
        </p:nvSpPr>
        <p:spPr>
          <a:xfrm>
            <a:off x="113576" y="88863"/>
            <a:ext cx="761747" cy="369332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</p:spPr>
        <p:txBody>
          <a:bodyPr wrap="none" rtlCol="0">
            <a:spAutoFit/>
          </a:bodyPr>
          <a:lstStyle/>
          <a:p>
            <a:r>
              <a:rPr lang="de-DE" dirty="0" err="1">
                <a:solidFill>
                  <a:schemeClr val="bg1"/>
                </a:solidFill>
              </a:rPr>
              <a:t>Sup</a:t>
            </a:r>
            <a:r>
              <a:rPr lang="de-DE" dirty="0">
                <a:solidFill>
                  <a:schemeClr val="bg1"/>
                </a:solidFill>
              </a:rPr>
              <a:t>. 2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1438640" y="-2660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1438640" y="1968376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1438640" y="4092692"/>
            <a:ext cx="3554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1295274" y="236319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258405" y="4478255"/>
            <a:ext cx="478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7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1239169" y="401409"/>
            <a:ext cx="4940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609717" y="6348346"/>
            <a:ext cx="42672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1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3244289" y="6354116"/>
            <a:ext cx="46358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I1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3852726" y="6354116"/>
            <a:ext cx="62549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luR5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Grafik 33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361" t="23445" r="69186" b="74686"/>
          <a:stretch/>
        </p:blipFill>
        <p:spPr>
          <a:xfrm>
            <a:off x="1645559" y="6370043"/>
            <a:ext cx="186264" cy="226722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135" t="31412" r="62560" b="66731"/>
          <a:stretch/>
        </p:blipFill>
        <p:spPr>
          <a:xfrm>
            <a:off x="2456274" y="6362052"/>
            <a:ext cx="156528" cy="210706"/>
          </a:xfrm>
          <a:prstGeom prst="rect">
            <a:avLst/>
          </a:prstGeom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2884" t="33871" r="35896" b="64538"/>
          <a:stretch/>
        </p:blipFill>
        <p:spPr>
          <a:xfrm>
            <a:off x="3090904" y="6381423"/>
            <a:ext cx="156470" cy="192883"/>
          </a:xfrm>
          <a:prstGeom prst="rect">
            <a:avLst/>
          </a:prstGeom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016F29A2-CC6C-9B42-9747-9753BF0678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3016" t="34233" r="15866" b="64512"/>
          <a:stretch/>
        </p:blipFill>
        <p:spPr>
          <a:xfrm>
            <a:off x="3705499" y="6409601"/>
            <a:ext cx="150312" cy="159544"/>
          </a:xfrm>
          <a:prstGeom prst="rect">
            <a:avLst/>
          </a:prstGeom>
        </p:spPr>
      </p:pic>
      <p:sp>
        <p:nvSpPr>
          <p:cNvPr id="38" name="Textfeld 37"/>
          <p:cNvSpPr txBox="1"/>
          <p:nvPr/>
        </p:nvSpPr>
        <p:spPr>
          <a:xfrm>
            <a:off x="1828738" y="6356125"/>
            <a:ext cx="61266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9" name="Objek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863587"/>
              </p:ext>
            </p:extLst>
          </p:nvPr>
        </p:nvGraphicFramePr>
        <p:xfrm>
          <a:off x="1645559" y="495299"/>
          <a:ext cx="2306637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0" name="Prism 9" r:id="rId4" imgW="2306669" imgH="1707490" progId="Prism9.Document">
                  <p:embed/>
                </p:oleObj>
              </mc:Choice>
              <mc:Fallback>
                <p:oleObj name="Prism 9" r:id="rId4" imgW="2306669" imgH="170749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45559" y="495299"/>
                        <a:ext cx="2306637" cy="170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k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170909"/>
              </p:ext>
            </p:extLst>
          </p:nvPr>
        </p:nvGraphicFramePr>
        <p:xfrm>
          <a:off x="3542394" y="225084"/>
          <a:ext cx="2306637" cy="1974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1" name="Prism 9" r:id="rId6" imgW="2306669" imgH="1974364" progId="Prism9.Document">
                  <p:embed/>
                </p:oleObj>
              </mc:Choice>
              <mc:Fallback>
                <p:oleObj name="Prism 9" r:id="rId6" imgW="2306669" imgH="1974364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42394" y="225084"/>
                        <a:ext cx="2306637" cy="1974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k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0719439"/>
              </p:ext>
            </p:extLst>
          </p:nvPr>
        </p:nvGraphicFramePr>
        <p:xfrm>
          <a:off x="5404077" y="495299"/>
          <a:ext cx="2306637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2" name="Prism 9" r:id="rId8" imgW="2306669" imgH="1707490" progId="Prism9.Document">
                  <p:embed/>
                </p:oleObj>
              </mc:Choice>
              <mc:Fallback>
                <p:oleObj name="Prism 9" r:id="rId8" imgW="2306669" imgH="170749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404077" y="495299"/>
                        <a:ext cx="2306637" cy="170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k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4560635"/>
              </p:ext>
            </p:extLst>
          </p:nvPr>
        </p:nvGraphicFramePr>
        <p:xfrm>
          <a:off x="7250795" y="495299"/>
          <a:ext cx="2224087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3" name="Prism 9" r:id="rId10" imgW="2224198" imgH="1707490" progId="Prism9.Document">
                  <p:embed/>
                </p:oleObj>
              </mc:Choice>
              <mc:Fallback>
                <p:oleObj name="Prism 9" r:id="rId10" imgW="2224198" imgH="170749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250795" y="495299"/>
                        <a:ext cx="2224087" cy="170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k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9240839"/>
              </p:ext>
            </p:extLst>
          </p:nvPr>
        </p:nvGraphicFramePr>
        <p:xfrm>
          <a:off x="1645559" y="2669266"/>
          <a:ext cx="2330450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4" name="Prism 9" r:id="rId12" imgW="2329718" imgH="1707490" progId="Prism9.Document">
                  <p:embed/>
                </p:oleObj>
              </mc:Choice>
              <mc:Fallback>
                <p:oleObj name="Prism 9" r:id="rId12" imgW="2329718" imgH="170749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645559" y="2669266"/>
                        <a:ext cx="2330450" cy="170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k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4053354"/>
              </p:ext>
            </p:extLst>
          </p:nvPr>
        </p:nvGraphicFramePr>
        <p:xfrm>
          <a:off x="3542394" y="2078716"/>
          <a:ext cx="2330450" cy="2298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5" name="Prism 9" r:id="rId14" imgW="2329718" imgH="2299223" progId="Prism9.Document">
                  <p:embed/>
                </p:oleObj>
              </mc:Choice>
              <mc:Fallback>
                <p:oleObj name="Prism 9" r:id="rId14" imgW="2329718" imgH="229922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42394" y="2078716"/>
                        <a:ext cx="2330450" cy="2298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k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1272787"/>
              </p:ext>
            </p:extLst>
          </p:nvPr>
        </p:nvGraphicFramePr>
        <p:xfrm>
          <a:off x="5404077" y="2528546"/>
          <a:ext cx="2330450" cy="185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6" name="Prism 9" r:id="rId16" imgW="2329718" imgH="1850832" progId="Prism9.Document">
                  <p:embed/>
                </p:oleObj>
              </mc:Choice>
              <mc:Fallback>
                <p:oleObj name="Prism 9" r:id="rId16" imgW="2329718" imgH="1850832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404077" y="2528546"/>
                        <a:ext cx="2330450" cy="1851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k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5668505"/>
              </p:ext>
            </p:extLst>
          </p:nvPr>
        </p:nvGraphicFramePr>
        <p:xfrm>
          <a:off x="7250795" y="2032679"/>
          <a:ext cx="2347913" cy="2344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7" name="Prism 9" r:id="rId18" imgW="2347725" imgH="2344963" progId="Prism9.Document">
                  <p:embed/>
                </p:oleObj>
              </mc:Choice>
              <mc:Fallback>
                <p:oleObj name="Prism 9" r:id="rId18" imgW="2347725" imgH="234496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7250795" y="2032679"/>
                        <a:ext cx="2347913" cy="2344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k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481203"/>
              </p:ext>
            </p:extLst>
          </p:nvPr>
        </p:nvGraphicFramePr>
        <p:xfrm>
          <a:off x="1645559" y="4591840"/>
          <a:ext cx="2330450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8" name="Prism 9" r:id="rId20" imgW="2329718" imgH="1707490" progId="Prism9.Document">
                  <p:embed/>
                </p:oleObj>
              </mc:Choice>
              <mc:Fallback>
                <p:oleObj name="Prism 9" r:id="rId20" imgW="2329718" imgH="170749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645559" y="4591840"/>
                        <a:ext cx="2330450" cy="170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k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6746297"/>
              </p:ext>
            </p:extLst>
          </p:nvPr>
        </p:nvGraphicFramePr>
        <p:xfrm>
          <a:off x="3542394" y="4275927"/>
          <a:ext cx="2330450" cy="2024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9" name="Prism 9" r:id="rId22" imgW="2329718" imgH="2023345" progId="Prism9.Document">
                  <p:embed/>
                </p:oleObj>
              </mc:Choice>
              <mc:Fallback>
                <p:oleObj name="Prism 9" r:id="rId22" imgW="2329718" imgH="202334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542394" y="4275927"/>
                        <a:ext cx="2330450" cy="2024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Objek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2888315"/>
              </p:ext>
            </p:extLst>
          </p:nvPr>
        </p:nvGraphicFramePr>
        <p:xfrm>
          <a:off x="5404077" y="4591840"/>
          <a:ext cx="2330450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0" name="Prism 9" r:id="rId24" imgW="2329718" imgH="1707490" progId="Prism9.Document">
                  <p:embed/>
                </p:oleObj>
              </mc:Choice>
              <mc:Fallback>
                <p:oleObj name="Prism 9" r:id="rId24" imgW="2329718" imgH="170749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5404077" y="4591840"/>
                        <a:ext cx="2330450" cy="170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Objekt 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8930762"/>
              </p:ext>
            </p:extLst>
          </p:nvPr>
        </p:nvGraphicFramePr>
        <p:xfrm>
          <a:off x="7250795" y="4285452"/>
          <a:ext cx="2330450" cy="2011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1" name="Prism 9" r:id="rId26" imgW="2329718" imgH="2011100" progId="Prism9.Document">
                  <p:embed/>
                </p:oleObj>
              </mc:Choice>
              <mc:Fallback>
                <p:oleObj name="Prism 9" r:id="rId26" imgW="2329718" imgH="2011100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7250795" y="4285452"/>
                        <a:ext cx="2330450" cy="2011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91087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2C5421E9556804786B763A71DF95625" ma:contentTypeVersion="8" ma:contentTypeDescription="Create a new document." ma:contentTypeScope="" ma:versionID="c06ccf65ad4e6d8b247333a40debc2f2">
  <xsd:schema xmlns:xsd="http://www.w3.org/2001/XMLSchema" xmlns:xs="http://www.w3.org/2001/XMLSchema" xmlns:p="http://schemas.microsoft.com/office/2006/metadata/properties" xmlns:ns3="a1d12c67-08e6-4d41-baed-b667b6327ea8" xmlns:ns4="c7591ff4-a3b1-46e7-9751-a5a9df55f467" targetNamespace="http://schemas.microsoft.com/office/2006/metadata/properties" ma:root="true" ma:fieldsID="11665868cd6f925d49f366492afda383" ns3:_="" ns4:_="">
    <xsd:import namespace="a1d12c67-08e6-4d41-baed-b667b6327ea8"/>
    <xsd:import namespace="c7591ff4-a3b1-46e7-9751-a5a9df55f46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_activity" minOccurs="0"/>
                <xsd:element ref="ns4:MediaServiceObjectDetectorVersion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1d12c67-08e6-4d41-baed-b667b6327ea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591ff4-a3b1-46e7-9751-a5a9df55f46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_activity" ma:index="13" nillable="true" ma:displayName="_activity" ma:hidden="true" ma:internalName="_activity">
      <xsd:simpleType>
        <xsd:restriction base="dms:Note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c7591ff4-a3b1-46e7-9751-a5a9df55f467" xsi:nil="true"/>
  </documentManagement>
</p:properties>
</file>

<file path=customXml/itemProps1.xml><?xml version="1.0" encoding="utf-8"?>
<ds:datastoreItem xmlns:ds="http://schemas.openxmlformats.org/officeDocument/2006/customXml" ds:itemID="{0818E192-C792-46B1-BAE9-83A7A8D9381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5E89628-9B9A-4BA3-93F1-8FCAC30E586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1d12c67-08e6-4d41-baed-b667b6327ea8"/>
    <ds:schemaRef ds:uri="c7591ff4-a3b1-46e7-9751-a5a9df55f46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171331BF-4621-4FF7-93A7-A8EEAC93DE0A}">
  <ds:schemaRefs>
    <ds:schemaRef ds:uri="http://schemas.microsoft.com/office/2006/documentManagement/types"/>
    <ds:schemaRef ds:uri="http://www.w3.org/XML/1998/namespace"/>
    <ds:schemaRef ds:uri="http://purl.org/dc/dcmitype/"/>
    <ds:schemaRef ds:uri="http://schemas.microsoft.com/office/infopath/2007/PartnerControls"/>
    <ds:schemaRef ds:uri="c7591ff4-a3b1-46e7-9751-a5a9df55f467"/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a1d12c67-08e6-4d41-baed-b667b6327ea8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rism 9</vt:lpstr>
      <vt:lpstr>PowerPoint Presentation</vt:lpstr>
      <vt:lpstr>PowerPoint Presentation</vt:lpstr>
    </vt:vector>
  </TitlesOfParts>
  <Company>DZ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egorio Spagni</dc:creator>
  <cp:lastModifiedBy>Raniel Serrano</cp:lastModifiedBy>
  <cp:revision>50</cp:revision>
  <dcterms:created xsi:type="dcterms:W3CDTF">2023-08-24T13:10:04Z</dcterms:created>
  <dcterms:modified xsi:type="dcterms:W3CDTF">2025-06-04T05:50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2C5421E9556804786B763A71DF95625</vt:lpwstr>
  </property>
</Properties>
</file>